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20"/>
  </p:notesMasterIdLst>
  <p:sldIdLst>
    <p:sldId id="268" r:id="rId5"/>
    <p:sldId id="257" r:id="rId6"/>
    <p:sldId id="273" r:id="rId7"/>
    <p:sldId id="260" r:id="rId8"/>
    <p:sldId id="261" r:id="rId9"/>
    <p:sldId id="259" r:id="rId10"/>
    <p:sldId id="262" r:id="rId11"/>
    <p:sldId id="266" r:id="rId12"/>
    <p:sldId id="263" r:id="rId13"/>
    <p:sldId id="256" r:id="rId14"/>
    <p:sldId id="258" r:id="rId15"/>
    <p:sldId id="271" r:id="rId16"/>
    <p:sldId id="265" r:id="rId17"/>
    <p:sldId id="269" r:id="rId18"/>
    <p:sldId id="272" r:id="rId19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F6257CE-5E82-1512-54E7-0D26BB427A47}" name="Qiu, Dike" initials="QD" userId="S::dike.qiu@bms.com::ad54f1ad-a1de-4756-b660-3804bdddd578" providerId="AD"/>
  <p188:author id="{DFB4AACE-AE7B-CA66-71E8-CE7E930012D8}" name="Arey, Brian" initials="AB" userId="S::brian.arey@bms.com::cd4c7147-d651-4cf6-916c-72cfa05ff466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rey, Brian" initials="AB" lastIdx="2" clrIdx="0">
    <p:extLst>
      <p:ext uri="{19B8F6BF-5375-455C-9EA6-DF929625EA0E}">
        <p15:presenceInfo xmlns:p15="http://schemas.microsoft.com/office/powerpoint/2012/main" userId="S-1-5-21-1085031214-73586283-839522115-6776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E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CC16841-AF7F-4A6E-B5E5-DE157320AC34}" v="25" dt="2023-05-12T18:10:48.62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465" autoAdjust="0"/>
    <p:restoredTop sz="92802" autoAdjust="0"/>
  </p:normalViewPr>
  <p:slideViewPr>
    <p:cSldViewPr snapToGrid="0">
      <p:cViewPr>
        <p:scale>
          <a:sx n="50" d="100"/>
          <a:sy n="50" d="100"/>
        </p:scale>
        <p:origin x="737" y="2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21" Type="http://schemas.openxmlformats.org/officeDocument/2006/relationships/commentAuthors" Target="commentAuthor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notesMaster" Target="notesMasters/notesMaster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theme" Target="theme/theme1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viewProps" Target="viewProps.xml"/><Relationship Id="rId28" Type="http://schemas.microsoft.com/office/2018/10/relationships/authors" Target="author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presProps" Target="presProps.xml"/><Relationship Id="rId27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rey, Brian" userId="cd4c7147-d651-4cf6-916c-72cfa05ff466" providerId="ADAL" clId="{ECC16841-AF7F-4A6E-B5E5-DE157320AC34}"/>
    <pc:docChg chg="undo custSel modSld">
      <pc:chgData name="Arey, Brian" userId="cd4c7147-d651-4cf6-916c-72cfa05ff466" providerId="ADAL" clId="{ECC16841-AF7F-4A6E-B5E5-DE157320AC34}" dt="2023-05-12T18:59:38.214" v="119" actId="1076"/>
      <pc:docMkLst>
        <pc:docMk/>
      </pc:docMkLst>
      <pc:sldChg chg="delSp mod">
        <pc:chgData name="Arey, Brian" userId="cd4c7147-d651-4cf6-916c-72cfa05ff466" providerId="ADAL" clId="{ECC16841-AF7F-4A6E-B5E5-DE157320AC34}" dt="2023-05-12T18:08:41.706" v="70" actId="21"/>
        <pc:sldMkLst>
          <pc:docMk/>
          <pc:sldMk cId="1396609983" sldId="256"/>
        </pc:sldMkLst>
        <pc:spChg chg="del">
          <ac:chgData name="Arey, Brian" userId="cd4c7147-d651-4cf6-916c-72cfa05ff466" providerId="ADAL" clId="{ECC16841-AF7F-4A6E-B5E5-DE157320AC34}" dt="2023-05-12T18:08:41.706" v="70" actId="21"/>
          <ac:spMkLst>
            <pc:docMk/>
            <pc:sldMk cId="1396609983" sldId="256"/>
            <ac:spMk id="8" creationId="{00000000-0000-0000-0000-000000000000}"/>
          </ac:spMkLst>
        </pc:spChg>
        <pc:spChg chg="del">
          <ac:chgData name="Arey, Brian" userId="cd4c7147-d651-4cf6-916c-72cfa05ff466" providerId="ADAL" clId="{ECC16841-AF7F-4A6E-B5E5-DE157320AC34}" dt="2023-05-12T18:08:41.706" v="70" actId="21"/>
          <ac:spMkLst>
            <pc:docMk/>
            <pc:sldMk cId="1396609983" sldId="256"/>
            <ac:spMk id="28" creationId="{00000000-0000-0000-0000-000000000000}"/>
          </ac:spMkLst>
        </pc:spChg>
        <pc:picChg chg="del">
          <ac:chgData name="Arey, Brian" userId="cd4c7147-d651-4cf6-916c-72cfa05ff466" providerId="ADAL" clId="{ECC16841-AF7F-4A6E-B5E5-DE157320AC34}" dt="2023-05-12T18:08:41.706" v="70" actId="21"/>
          <ac:picMkLst>
            <pc:docMk/>
            <pc:sldMk cId="1396609983" sldId="256"/>
            <ac:picMk id="2" creationId="{00000000-0000-0000-0000-000000000000}"/>
          </ac:picMkLst>
        </pc:picChg>
        <pc:picChg chg="del">
          <ac:chgData name="Arey, Brian" userId="cd4c7147-d651-4cf6-916c-72cfa05ff466" providerId="ADAL" clId="{ECC16841-AF7F-4A6E-B5E5-DE157320AC34}" dt="2023-05-12T18:08:41.706" v="70" actId="21"/>
          <ac:picMkLst>
            <pc:docMk/>
            <pc:sldMk cId="1396609983" sldId="256"/>
            <ac:picMk id="33" creationId="{00000000-0000-0000-0000-000000000000}"/>
          </ac:picMkLst>
        </pc:picChg>
      </pc:sldChg>
      <pc:sldChg chg="delSp">
        <pc:chgData name="Arey, Brian" userId="cd4c7147-d651-4cf6-916c-72cfa05ff466" providerId="ADAL" clId="{ECC16841-AF7F-4A6E-B5E5-DE157320AC34}" dt="2023-05-12T18:05:46.337" v="18" actId="21"/>
        <pc:sldMkLst>
          <pc:docMk/>
          <pc:sldMk cId="680808174" sldId="257"/>
        </pc:sldMkLst>
        <pc:spChg chg="del">
          <ac:chgData name="Arey, Brian" userId="cd4c7147-d651-4cf6-916c-72cfa05ff466" providerId="ADAL" clId="{ECC16841-AF7F-4A6E-B5E5-DE157320AC34}" dt="2023-05-12T18:05:46.337" v="18" actId="21"/>
          <ac:spMkLst>
            <pc:docMk/>
            <pc:sldMk cId="680808174" sldId="257"/>
            <ac:spMk id="15" creationId="{2DBD2E69-82B8-4C4E-9E72-214C149384FA}"/>
          </ac:spMkLst>
        </pc:spChg>
        <pc:spChg chg="del">
          <ac:chgData name="Arey, Brian" userId="cd4c7147-d651-4cf6-916c-72cfa05ff466" providerId="ADAL" clId="{ECC16841-AF7F-4A6E-B5E5-DE157320AC34}" dt="2023-05-12T18:05:46.337" v="18" actId="21"/>
          <ac:spMkLst>
            <pc:docMk/>
            <pc:sldMk cId="680808174" sldId="257"/>
            <ac:spMk id="16" creationId="{4761CB33-9732-499B-8D72-AAC5CF2D2833}"/>
          </ac:spMkLst>
        </pc:spChg>
        <pc:spChg chg="del">
          <ac:chgData name="Arey, Brian" userId="cd4c7147-d651-4cf6-916c-72cfa05ff466" providerId="ADAL" clId="{ECC16841-AF7F-4A6E-B5E5-DE157320AC34}" dt="2023-05-12T18:05:46.337" v="18" actId="21"/>
          <ac:spMkLst>
            <pc:docMk/>
            <pc:sldMk cId="680808174" sldId="257"/>
            <ac:spMk id="17" creationId="{A908B62B-A6A5-42ED-8239-4AD7E17DE00F}"/>
          </ac:spMkLst>
        </pc:spChg>
        <pc:spChg chg="del">
          <ac:chgData name="Arey, Brian" userId="cd4c7147-d651-4cf6-916c-72cfa05ff466" providerId="ADAL" clId="{ECC16841-AF7F-4A6E-B5E5-DE157320AC34}" dt="2023-05-12T18:05:46.337" v="18" actId="21"/>
          <ac:spMkLst>
            <pc:docMk/>
            <pc:sldMk cId="680808174" sldId="257"/>
            <ac:spMk id="19" creationId="{54F26208-7244-4C9C-A839-1E7DA409D68D}"/>
          </ac:spMkLst>
        </pc:spChg>
        <pc:grpChg chg="del">
          <ac:chgData name="Arey, Brian" userId="cd4c7147-d651-4cf6-916c-72cfa05ff466" providerId="ADAL" clId="{ECC16841-AF7F-4A6E-B5E5-DE157320AC34}" dt="2023-05-12T18:05:46.337" v="18" actId="21"/>
          <ac:grpSpMkLst>
            <pc:docMk/>
            <pc:sldMk cId="680808174" sldId="257"/>
            <ac:grpSpMk id="5" creationId="{646E5E7C-C078-A347-7380-4AF0F649A95A}"/>
          </ac:grpSpMkLst>
        </pc:grpChg>
        <pc:grpChg chg="del">
          <ac:chgData name="Arey, Brian" userId="cd4c7147-d651-4cf6-916c-72cfa05ff466" providerId="ADAL" clId="{ECC16841-AF7F-4A6E-B5E5-DE157320AC34}" dt="2023-05-12T18:05:46.337" v="18" actId="21"/>
          <ac:grpSpMkLst>
            <pc:docMk/>
            <pc:sldMk cId="680808174" sldId="257"/>
            <ac:grpSpMk id="42" creationId="{5B005001-F784-4D9F-8B2F-74828F47FA3F}"/>
          </ac:grpSpMkLst>
        </pc:grpChg>
        <pc:grpChg chg="del">
          <ac:chgData name="Arey, Brian" userId="cd4c7147-d651-4cf6-916c-72cfa05ff466" providerId="ADAL" clId="{ECC16841-AF7F-4A6E-B5E5-DE157320AC34}" dt="2023-05-12T18:05:46.337" v="18" actId="21"/>
          <ac:grpSpMkLst>
            <pc:docMk/>
            <pc:sldMk cId="680808174" sldId="257"/>
            <ac:grpSpMk id="44" creationId="{6963DE2C-F016-4996-A268-43B5DD1E54BE}"/>
          </ac:grpSpMkLst>
        </pc:grpChg>
        <pc:picChg chg="del">
          <ac:chgData name="Arey, Brian" userId="cd4c7147-d651-4cf6-916c-72cfa05ff466" providerId="ADAL" clId="{ECC16841-AF7F-4A6E-B5E5-DE157320AC34}" dt="2023-05-12T18:05:46.337" v="18" actId="21"/>
          <ac:picMkLst>
            <pc:docMk/>
            <pc:sldMk cId="680808174" sldId="257"/>
            <ac:picMk id="24" creationId="{8783998E-DB4C-07B9-A18D-5E466CBB92C9}"/>
          </ac:picMkLst>
        </pc:picChg>
      </pc:sldChg>
      <pc:sldChg chg="addSp delSp modSp mod">
        <pc:chgData name="Arey, Brian" userId="cd4c7147-d651-4cf6-916c-72cfa05ff466" providerId="ADAL" clId="{ECC16841-AF7F-4A6E-B5E5-DE157320AC34}" dt="2023-05-12T18:28:24.294" v="105" actId="20577"/>
        <pc:sldMkLst>
          <pc:docMk/>
          <pc:sldMk cId="1256955178" sldId="258"/>
        </pc:sldMkLst>
        <pc:spChg chg="mod">
          <ac:chgData name="Arey, Brian" userId="cd4c7147-d651-4cf6-916c-72cfa05ff466" providerId="ADAL" clId="{ECC16841-AF7F-4A6E-B5E5-DE157320AC34}" dt="2023-05-12T18:28:24.294" v="105" actId="20577"/>
          <ac:spMkLst>
            <pc:docMk/>
            <pc:sldMk cId="1256955178" sldId="258"/>
            <ac:spMk id="2" creationId="{00000000-0000-0000-0000-000000000000}"/>
          </ac:spMkLst>
        </pc:spChg>
        <pc:spChg chg="add del">
          <ac:chgData name="Arey, Brian" userId="cd4c7147-d651-4cf6-916c-72cfa05ff466" providerId="ADAL" clId="{ECC16841-AF7F-4A6E-B5E5-DE157320AC34}" dt="2023-05-12T18:09:10.508" v="73" actId="21"/>
          <ac:spMkLst>
            <pc:docMk/>
            <pc:sldMk cId="1256955178" sldId="258"/>
            <ac:spMk id="7" creationId="{00000000-0000-0000-0000-000000000000}"/>
          </ac:spMkLst>
        </pc:spChg>
        <pc:spChg chg="add del">
          <ac:chgData name="Arey, Brian" userId="cd4c7147-d651-4cf6-916c-72cfa05ff466" providerId="ADAL" clId="{ECC16841-AF7F-4A6E-B5E5-DE157320AC34}" dt="2023-05-12T18:09:10.508" v="73" actId="21"/>
          <ac:spMkLst>
            <pc:docMk/>
            <pc:sldMk cId="1256955178" sldId="258"/>
            <ac:spMk id="12" creationId="{340A17E3-EAAE-7736-518F-B5BBA583D2F0}"/>
          </ac:spMkLst>
        </pc:spChg>
        <pc:spChg chg="add del">
          <ac:chgData name="Arey, Brian" userId="cd4c7147-d651-4cf6-916c-72cfa05ff466" providerId="ADAL" clId="{ECC16841-AF7F-4A6E-B5E5-DE157320AC34}" dt="2023-05-12T18:09:10.508" v="73" actId="21"/>
          <ac:spMkLst>
            <pc:docMk/>
            <pc:sldMk cId="1256955178" sldId="258"/>
            <ac:spMk id="19" creationId="{00000000-0000-0000-0000-000000000000}"/>
          </ac:spMkLst>
        </pc:spChg>
        <pc:grpChg chg="add del">
          <ac:chgData name="Arey, Brian" userId="cd4c7147-d651-4cf6-916c-72cfa05ff466" providerId="ADAL" clId="{ECC16841-AF7F-4A6E-B5E5-DE157320AC34}" dt="2023-05-12T18:09:10.508" v="73" actId="21"/>
          <ac:grpSpMkLst>
            <pc:docMk/>
            <pc:sldMk cId="1256955178" sldId="258"/>
            <ac:grpSpMk id="9" creationId="{00000000-0000-0000-0000-000000000000}"/>
          </ac:grpSpMkLst>
        </pc:grpChg>
        <pc:grpChg chg="del">
          <ac:chgData name="Arey, Brian" userId="cd4c7147-d651-4cf6-916c-72cfa05ff466" providerId="ADAL" clId="{ECC16841-AF7F-4A6E-B5E5-DE157320AC34}" dt="2023-05-12T18:09:10.508" v="73" actId="21"/>
          <ac:grpSpMkLst>
            <pc:docMk/>
            <pc:sldMk cId="1256955178" sldId="258"/>
            <ac:grpSpMk id="11" creationId="{1799B68B-E6D4-40D2-9110-BE03B098BD62}"/>
          </ac:grpSpMkLst>
        </pc:grpChg>
        <pc:picChg chg="add del">
          <ac:chgData name="Arey, Brian" userId="cd4c7147-d651-4cf6-916c-72cfa05ff466" providerId="ADAL" clId="{ECC16841-AF7F-4A6E-B5E5-DE157320AC34}" dt="2023-05-12T18:09:10.508" v="73" actId="21"/>
          <ac:picMkLst>
            <pc:docMk/>
            <pc:sldMk cId="1256955178" sldId="258"/>
            <ac:picMk id="4" creationId="{00000000-0000-0000-0000-000000000000}"/>
          </ac:picMkLst>
        </pc:picChg>
        <pc:picChg chg="mod">
          <ac:chgData name="Arey, Brian" userId="cd4c7147-d651-4cf6-916c-72cfa05ff466" providerId="ADAL" clId="{ECC16841-AF7F-4A6E-B5E5-DE157320AC34}" dt="2023-05-12T18:09:23.835" v="74" actId="1076"/>
          <ac:picMkLst>
            <pc:docMk/>
            <pc:sldMk cId="1256955178" sldId="258"/>
            <ac:picMk id="6" creationId="{A9FC629B-CBFF-AEC3-CC85-D48E1F4D6B64}"/>
          </ac:picMkLst>
        </pc:picChg>
      </pc:sldChg>
      <pc:sldChg chg="delSp modSp mod">
        <pc:chgData name="Arey, Brian" userId="cd4c7147-d651-4cf6-916c-72cfa05ff466" providerId="ADAL" clId="{ECC16841-AF7F-4A6E-B5E5-DE157320AC34}" dt="2023-05-12T18:07:22.047" v="58" actId="1035"/>
        <pc:sldMkLst>
          <pc:docMk/>
          <pc:sldMk cId="2694573636" sldId="259"/>
        </pc:sldMkLst>
        <pc:spChg chg="mod">
          <ac:chgData name="Arey, Brian" userId="cd4c7147-d651-4cf6-916c-72cfa05ff466" providerId="ADAL" clId="{ECC16841-AF7F-4A6E-B5E5-DE157320AC34}" dt="2023-05-12T18:07:01.236" v="29" actId="1076"/>
          <ac:spMkLst>
            <pc:docMk/>
            <pc:sldMk cId="2694573636" sldId="259"/>
            <ac:spMk id="2" creationId="{00000000-0000-0000-0000-000000000000}"/>
          </ac:spMkLst>
        </pc:spChg>
        <pc:spChg chg="del">
          <ac:chgData name="Arey, Brian" userId="cd4c7147-d651-4cf6-916c-72cfa05ff466" providerId="ADAL" clId="{ECC16841-AF7F-4A6E-B5E5-DE157320AC34}" dt="2023-05-12T18:07:09.716" v="30" actId="21"/>
          <ac:spMkLst>
            <pc:docMk/>
            <pc:sldMk cId="2694573636" sldId="259"/>
            <ac:spMk id="9" creationId="{1D223938-EB08-6F08-6A3E-0794F35F8B2C}"/>
          </ac:spMkLst>
        </pc:spChg>
        <pc:spChg chg="del">
          <ac:chgData name="Arey, Brian" userId="cd4c7147-d651-4cf6-916c-72cfa05ff466" providerId="ADAL" clId="{ECC16841-AF7F-4A6E-B5E5-DE157320AC34}" dt="2023-05-12T18:07:09.716" v="30" actId="21"/>
          <ac:spMkLst>
            <pc:docMk/>
            <pc:sldMk cId="2694573636" sldId="259"/>
            <ac:spMk id="15" creationId="{00000000-0000-0000-0000-000000000000}"/>
          </ac:spMkLst>
        </pc:spChg>
        <pc:spChg chg="del">
          <ac:chgData name="Arey, Brian" userId="cd4c7147-d651-4cf6-916c-72cfa05ff466" providerId="ADAL" clId="{ECC16841-AF7F-4A6E-B5E5-DE157320AC34}" dt="2023-05-12T18:07:09.716" v="30" actId="21"/>
          <ac:spMkLst>
            <pc:docMk/>
            <pc:sldMk cId="2694573636" sldId="259"/>
            <ac:spMk id="17" creationId="{00000000-0000-0000-0000-000000000000}"/>
          </ac:spMkLst>
        </pc:spChg>
        <pc:grpChg chg="del">
          <ac:chgData name="Arey, Brian" userId="cd4c7147-d651-4cf6-916c-72cfa05ff466" providerId="ADAL" clId="{ECC16841-AF7F-4A6E-B5E5-DE157320AC34}" dt="2023-05-12T18:07:09.716" v="30" actId="21"/>
          <ac:grpSpMkLst>
            <pc:docMk/>
            <pc:sldMk cId="2694573636" sldId="259"/>
            <ac:grpSpMk id="10" creationId="{C90AE354-132B-40A5-BE82-C387FCD19238}"/>
          </ac:grpSpMkLst>
        </pc:grpChg>
        <pc:picChg chg="del">
          <ac:chgData name="Arey, Brian" userId="cd4c7147-d651-4cf6-916c-72cfa05ff466" providerId="ADAL" clId="{ECC16841-AF7F-4A6E-B5E5-DE157320AC34}" dt="2023-05-12T18:07:09.716" v="30" actId="21"/>
          <ac:picMkLst>
            <pc:docMk/>
            <pc:sldMk cId="2694573636" sldId="259"/>
            <ac:picMk id="7" creationId="{004DF30F-D178-4AE9-AEFE-2D59F0AD7097}"/>
          </ac:picMkLst>
        </pc:picChg>
        <pc:picChg chg="del">
          <ac:chgData name="Arey, Brian" userId="cd4c7147-d651-4cf6-916c-72cfa05ff466" providerId="ADAL" clId="{ECC16841-AF7F-4A6E-B5E5-DE157320AC34}" dt="2023-05-12T18:07:09.716" v="30" actId="21"/>
          <ac:picMkLst>
            <pc:docMk/>
            <pc:sldMk cId="2694573636" sldId="259"/>
            <ac:picMk id="8" creationId="{A083D8A8-D709-4EA2-9AA3-D5E29C3DCF0F}"/>
          </ac:picMkLst>
        </pc:picChg>
        <pc:picChg chg="mod">
          <ac:chgData name="Arey, Brian" userId="cd4c7147-d651-4cf6-916c-72cfa05ff466" providerId="ADAL" clId="{ECC16841-AF7F-4A6E-B5E5-DE157320AC34}" dt="2023-05-12T18:07:22.047" v="58" actId="1035"/>
          <ac:picMkLst>
            <pc:docMk/>
            <pc:sldMk cId="2694573636" sldId="259"/>
            <ac:picMk id="11" creationId="{3BE873D0-6499-3327-35AF-8CCE8BBB1C49}"/>
          </ac:picMkLst>
        </pc:picChg>
      </pc:sldChg>
      <pc:sldChg chg="addSp delSp modSp mod">
        <pc:chgData name="Arey, Brian" userId="cd4c7147-d651-4cf6-916c-72cfa05ff466" providerId="ADAL" clId="{ECC16841-AF7F-4A6E-B5E5-DE157320AC34}" dt="2023-05-12T18:05:22.338" v="17" actId="21"/>
        <pc:sldMkLst>
          <pc:docMk/>
          <pc:sldMk cId="2579777712" sldId="260"/>
        </pc:sldMkLst>
        <pc:spChg chg="add del">
          <ac:chgData name="Arey, Brian" userId="cd4c7147-d651-4cf6-916c-72cfa05ff466" providerId="ADAL" clId="{ECC16841-AF7F-4A6E-B5E5-DE157320AC34}" dt="2023-05-12T18:05:22.338" v="17" actId="21"/>
          <ac:spMkLst>
            <pc:docMk/>
            <pc:sldMk cId="2579777712" sldId="260"/>
            <ac:spMk id="5" creationId="{81C48BB4-D004-AB99-BA6D-8965DD43C20B}"/>
          </ac:spMkLst>
        </pc:spChg>
        <pc:spChg chg="add del">
          <ac:chgData name="Arey, Brian" userId="cd4c7147-d651-4cf6-916c-72cfa05ff466" providerId="ADAL" clId="{ECC16841-AF7F-4A6E-B5E5-DE157320AC34}" dt="2023-05-12T18:05:22.338" v="17" actId="21"/>
          <ac:spMkLst>
            <pc:docMk/>
            <pc:sldMk cId="2579777712" sldId="260"/>
            <ac:spMk id="8" creationId="{00000000-0000-0000-0000-000000000000}"/>
          </ac:spMkLst>
        </pc:spChg>
        <pc:spChg chg="add del">
          <ac:chgData name="Arey, Brian" userId="cd4c7147-d651-4cf6-916c-72cfa05ff466" providerId="ADAL" clId="{ECC16841-AF7F-4A6E-B5E5-DE157320AC34}" dt="2023-05-12T18:05:22.338" v="17" actId="21"/>
          <ac:spMkLst>
            <pc:docMk/>
            <pc:sldMk cId="2579777712" sldId="260"/>
            <ac:spMk id="18" creationId="{9F765D80-A217-9FAC-C0EE-B13DFDCF5FEC}"/>
          </ac:spMkLst>
        </pc:spChg>
        <pc:spChg chg="add del">
          <ac:chgData name="Arey, Brian" userId="cd4c7147-d651-4cf6-916c-72cfa05ff466" providerId="ADAL" clId="{ECC16841-AF7F-4A6E-B5E5-DE157320AC34}" dt="2023-05-12T18:05:22.338" v="17" actId="21"/>
          <ac:spMkLst>
            <pc:docMk/>
            <pc:sldMk cId="2579777712" sldId="260"/>
            <ac:spMk id="20" creationId="{00047EDF-DD81-26B8-578E-0D122AE973AC}"/>
          </ac:spMkLst>
        </pc:spChg>
        <pc:spChg chg="add del">
          <ac:chgData name="Arey, Brian" userId="cd4c7147-d651-4cf6-916c-72cfa05ff466" providerId="ADAL" clId="{ECC16841-AF7F-4A6E-B5E5-DE157320AC34}" dt="2023-05-12T18:05:22.338" v="17" actId="21"/>
          <ac:spMkLst>
            <pc:docMk/>
            <pc:sldMk cId="2579777712" sldId="260"/>
            <ac:spMk id="23" creationId="{00000000-0000-0000-0000-000000000000}"/>
          </ac:spMkLst>
        </pc:spChg>
        <pc:spChg chg="add del">
          <ac:chgData name="Arey, Brian" userId="cd4c7147-d651-4cf6-916c-72cfa05ff466" providerId="ADAL" clId="{ECC16841-AF7F-4A6E-B5E5-DE157320AC34}" dt="2023-05-12T18:05:22.338" v="17" actId="21"/>
          <ac:spMkLst>
            <pc:docMk/>
            <pc:sldMk cId="2579777712" sldId="260"/>
            <ac:spMk id="24" creationId="{629A2E8F-CD1A-460E-A0FE-E16C4D73D491}"/>
          </ac:spMkLst>
        </pc:spChg>
        <pc:spChg chg="del">
          <ac:chgData name="Arey, Brian" userId="cd4c7147-d651-4cf6-916c-72cfa05ff466" providerId="ADAL" clId="{ECC16841-AF7F-4A6E-B5E5-DE157320AC34}" dt="2023-05-12T18:05:22.338" v="17" actId="21"/>
          <ac:spMkLst>
            <pc:docMk/>
            <pc:sldMk cId="2579777712" sldId="260"/>
            <ac:spMk id="27" creationId="{00000000-0000-0000-0000-000000000000}"/>
          </ac:spMkLst>
        </pc:spChg>
        <pc:spChg chg="add del">
          <ac:chgData name="Arey, Brian" userId="cd4c7147-d651-4cf6-916c-72cfa05ff466" providerId="ADAL" clId="{ECC16841-AF7F-4A6E-B5E5-DE157320AC34}" dt="2023-05-12T18:05:22.338" v="17" actId="21"/>
          <ac:spMkLst>
            <pc:docMk/>
            <pc:sldMk cId="2579777712" sldId="260"/>
            <ac:spMk id="31" creationId="{00000000-0000-0000-0000-000000000000}"/>
          </ac:spMkLst>
        </pc:spChg>
        <pc:spChg chg="add del">
          <ac:chgData name="Arey, Brian" userId="cd4c7147-d651-4cf6-916c-72cfa05ff466" providerId="ADAL" clId="{ECC16841-AF7F-4A6E-B5E5-DE157320AC34}" dt="2023-05-12T18:05:22.338" v="17" actId="21"/>
          <ac:spMkLst>
            <pc:docMk/>
            <pc:sldMk cId="2579777712" sldId="260"/>
            <ac:spMk id="32" creationId="{00000000-0000-0000-0000-000000000000}"/>
          </ac:spMkLst>
        </pc:spChg>
        <pc:spChg chg="add del">
          <ac:chgData name="Arey, Brian" userId="cd4c7147-d651-4cf6-916c-72cfa05ff466" providerId="ADAL" clId="{ECC16841-AF7F-4A6E-B5E5-DE157320AC34}" dt="2023-05-12T18:05:22.338" v="17" actId="21"/>
          <ac:spMkLst>
            <pc:docMk/>
            <pc:sldMk cId="2579777712" sldId="260"/>
            <ac:spMk id="33" creationId="{00000000-0000-0000-0000-000000000000}"/>
          </ac:spMkLst>
        </pc:spChg>
        <pc:grpChg chg="add del">
          <ac:chgData name="Arey, Brian" userId="cd4c7147-d651-4cf6-916c-72cfa05ff466" providerId="ADAL" clId="{ECC16841-AF7F-4A6E-B5E5-DE157320AC34}" dt="2023-05-12T18:05:22.338" v="17" actId="21"/>
          <ac:grpSpMkLst>
            <pc:docMk/>
            <pc:sldMk cId="2579777712" sldId="260"/>
            <ac:grpSpMk id="11" creationId="{00F7A224-FC81-4C22-9F4E-0E3262CB061C}"/>
          </ac:grpSpMkLst>
        </pc:grpChg>
        <pc:grpChg chg="add del">
          <ac:chgData name="Arey, Brian" userId="cd4c7147-d651-4cf6-916c-72cfa05ff466" providerId="ADAL" clId="{ECC16841-AF7F-4A6E-B5E5-DE157320AC34}" dt="2023-05-12T18:05:22.338" v="17" actId="21"/>
          <ac:grpSpMkLst>
            <pc:docMk/>
            <pc:sldMk cId="2579777712" sldId="260"/>
            <ac:grpSpMk id="12" creationId="{B6924FD6-1038-4B46-BF14-FBF3103EF199}"/>
          </ac:grpSpMkLst>
        </pc:grpChg>
        <pc:graphicFrameChg chg="add del">
          <ac:chgData name="Arey, Brian" userId="cd4c7147-d651-4cf6-916c-72cfa05ff466" providerId="ADAL" clId="{ECC16841-AF7F-4A6E-B5E5-DE157320AC34}" dt="2023-05-12T18:05:22.338" v="17" actId="21"/>
          <ac:graphicFrameMkLst>
            <pc:docMk/>
            <pc:sldMk cId="2579777712" sldId="260"/>
            <ac:graphicFrameMk id="35" creationId="{00000000-0000-0000-0000-000000000000}"/>
          </ac:graphicFrameMkLst>
        </pc:graphicFrameChg>
        <pc:picChg chg="add del">
          <ac:chgData name="Arey, Brian" userId="cd4c7147-d651-4cf6-916c-72cfa05ff466" providerId="ADAL" clId="{ECC16841-AF7F-4A6E-B5E5-DE157320AC34}" dt="2023-05-12T18:05:22.338" v="17" actId="21"/>
          <ac:picMkLst>
            <pc:docMk/>
            <pc:sldMk cId="2579777712" sldId="260"/>
            <ac:picMk id="6" creationId="{00000000-0000-0000-0000-000000000000}"/>
          </ac:picMkLst>
        </pc:picChg>
        <pc:picChg chg="add del">
          <ac:chgData name="Arey, Brian" userId="cd4c7147-d651-4cf6-916c-72cfa05ff466" providerId="ADAL" clId="{ECC16841-AF7F-4A6E-B5E5-DE157320AC34}" dt="2023-05-12T18:05:22.338" v="17" actId="21"/>
          <ac:picMkLst>
            <pc:docMk/>
            <pc:sldMk cId="2579777712" sldId="260"/>
            <ac:picMk id="9" creationId="{F0BAEDBE-168E-35AD-7764-C3D4E33B23E9}"/>
          </ac:picMkLst>
        </pc:picChg>
        <pc:picChg chg="del mod">
          <ac:chgData name="Arey, Brian" userId="cd4c7147-d651-4cf6-916c-72cfa05ff466" providerId="ADAL" clId="{ECC16841-AF7F-4A6E-B5E5-DE157320AC34}" dt="2023-05-12T18:05:16.844" v="15"/>
          <ac:picMkLst>
            <pc:docMk/>
            <pc:sldMk cId="2579777712" sldId="260"/>
            <ac:picMk id="13" creationId="{0C016B31-69BD-966B-16A2-8E1F178C2694}"/>
          </ac:picMkLst>
        </pc:picChg>
        <pc:picChg chg="add del">
          <ac:chgData name="Arey, Brian" userId="cd4c7147-d651-4cf6-916c-72cfa05ff466" providerId="ADAL" clId="{ECC16841-AF7F-4A6E-B5E5-DE157320AC34}" dt="2023-05-12T18:05:22.338" v="17" actId="21"/>
          <ac:picMkLst>
            <pc:docMk/>
            <pc:sldMk cId="2579777712" sldId="260"/>
            <ac:picMk id="17" creationId="{00000000-0000-0000-0000-000000000000}"/>
          </ac:picMkLst>
        </pc:picChg>
        <pc:picChg chg="add del">
          <ac:chgData name="Arey, Brian" userId="cd4c7147-d651-4cf6-916c-72cfa05ff466" providerId="ADAL" clId="{ECC16841-AF7F-4A6E-B5E5-DE157320AC34}" dt="2023-05-12T18:05:22.338" v="17" actId="21"/>
          <ac:picMkLst>
            <pc:docMk/>
            <pc:sldMk cId="2579777712" sldId="260"/>
            <ac:picMk id="30" creationId="{00000000-0000-0000-0000-000000000000}"/>
          </ac:picMkLst>
        </pc:picChg>
        <pc:cxnChg chg="add del">
          <ac:chgData name="Arey, Brian" userId="cd4c7147-d651-4cf6-916c-72cfa05ff466" providerId="ADAL" clId="{ECC16841-AF7F-4A6E-B5E5-DE157320AC34}" dt="2023-05-12T18:05:22.338" v="17" actId="21"/>
          <ac:cxnSpMkLst>
            <pc:docMk/>
            <pc:sldMk cId="2579777712" sldId="260"/>
            <ac:cxnSpMk id="10" creationId="{00000000-0000-0000-0000-000000000000}"/>
          </ac:cxnSpMkLst>
        </pc:cxnChg>
      </pc:sldChg>
      <pc:sldChg chg="delSp modSp mod">
        <pc:chgData name="Arey, Brian" userId="cd4c7147-d651-4cf6-916c-72cfa05ff466" providerId="ADAL" clId="{ECC16841-AF7F-4A6E-B5E5-DE157320AC34}" dt="2023-05-12T18:17:47.084" v="99" actId="20577"/>
        <pc:sldMkLst>
          <pc:docMk/>
          <pc:sldMk cId="1337482555" sldId="261"/>
        </pc:sldMkLst>
        <pc:spChg chg="mod">
          <ac:chgData name="Arey, Brian" userId="cd4c7147-d651-4cf6-916c-72cfa05ff466" providerId="ADAL" clId="{ECC16841-AF7F-4A6E-B5E5-DE157320AC34}" dt="2023-05-12T18:17:47.084" v="99" actId="20577"/>
          <ac:spMkLst>
            <pc:docMk/>
            <pc:sldMk cId="1337482555" sldId="261"/>
            <ac:spMk id="2" creationId="{00000000-0000-0000-0000-000000000000}"/>
          </ac:spMkLst>
        </pc:spChg>
        <pc:spChg chg="del">
          <ac:chgData name="Arey, Brian" userId="cd4c7147-d651-4cf6-916c-72cfa05ff466" providerId="ADAL" clId="{ECC16841-AF7F-4A6E-B5E5-DE157320AC34}" dt="2023-05-12T18:06:34.557" v="20" actId="21"/>
          <ac:spMkLst>
            <pc:docMk/>
            <pc:sldMk cId="1337482555" sldId="261"/>
            <ac:spMk id="28" creationId="{DA38F1AB-0E9D-4C98-8310-176F1EC94088}"/>
          </ac:spMkLst>
        </pc:spChg>
        <pc:spChg chg="del">
          <ac:chgData name="Arey, Brian" userId="cd4c7147-d651-4cf6-916c-72cfa05ff466" providerId="ADAL" clId="{ECC16841-AF7F-4A6E-B5E5-DE157320AC34}" dt="2023-05-12T18:06:34.557" v="20" actId="21"/>
          <ac:spMkLst>
            <pc:docMk/>
            <pc:sldMk cId="1337482555" sldId="261"/>
            <ac:spMk id="42" creationId="{00000000-0000-0000-0000-000000000000}"/>
          </ac:spMkLst>
        </pc:spChg>
        <pc:spChg chg="del">
          <ac:chgData name="Arey, Brian" userId="cd4c7147-d651-4cf6-916c-72cfa05ff466" providerId="ADAL" clId="{ECC16841-AF7F-4A6E-B5E5-DE157320AC34}" dt="2023-05-12T18:06:34.557" v="20" actId="21"/>
          <ac:spMkLst>
            <pc:docMk/>
            <pc:sldMk cId="1337482555" sldId="261"/>
            <ac:spMk id="43" creationId="{00000000-0000-0000-0000-000000000000}"/>
          </ac:spMkLst>
        </pc:spChg>
        <pc:spChg chg="del">
          <ac:chgData name="Arey, Brian" userId="cd4c7147-d651-4cf6-916c-72cfa05ff466" providerId="ADAL" clId="{ECC16841-AF7F-4A6E-B5E5-DE157320AC34}" dt="2023-05-12T18:06:34.557" v="20" actId="21"/>
          <ac:spMkLst>
            <pc:docMk/>
            <pc:sldMk cId="1337482555" sldId="261"/>
            <ac:spMk id="44" creationId="{00000000-0000-0000-0000-000000000000}"/>
          </ac:spMkLst>
        </pc:spChg>
        <pc:spChg chg="del">
          <ac:chgData name="Arey, Brian" userId="cd4c7147-d651-4cf6-916c-72cfa05ff466" providerId="ADAL" clId="{ECC16841-AF7F-4A6E-B5E5-DE157320AC34}" dt="2023-05-12T18:06:34.557" v="20" actId="21"/>
          <ac:spMkLst>
            <pc:docMk/>
            <pc:sldMk cId="1337482555" sldId="261"/>
            <ac:spMk id="46" creationId="{536A2266-CD5D-40EB-A65A-2303AF454151}"/>
          </ac:spMkLst>
        </pc:spChg>
        <pc:spChg chg="del">
          <ac:chgData name="Arey, Brian" userId="cd4c7147-d651-4cf6-916c-72cfa05ff466" providerId="ADAL" clId="{ECC16841-AF7F-4A6E-B5E5-DE157320AC34}" dt="2023-05-12T18:06:34.557" v="20" actId="21"/>
          <ac:spMkLst>
            <pc:docMk/>
            <pc:sldMk cId="1337482555" sldId="261"/>
            <ac:spMk id="52" creationId="{2A760A1A-0F3A-451F-A5BB-28D38F9C4712}"/>
          </ac:spMkLst>
        </pc:spChg>
        <pc:spChg chg="del">
          <ac:chgData name="Arey, Brian" userId="cd4c7147-d651-4cf6-916c-72cfa05ff466" providerId="ADAL" clId="{ECC16841-AF7F-4A6E-B5E5-DE157320AC34}" dt="2023-05-12T18:06:34.557" v="20" actId="21"/>
          <ac:spMkLst>
            <pc:docMk/>
            <pc:sldMk cId="1337482555" sldId="261"/>
            <ac:spMk id="53" creationId="{100521C0-4E9D-4AB4-BEC9-678E4A0F1CF3}"/>
          </ac:spMkLst>
        </pc:spChg>
        <pc:spChg chg="del">
          <ac:chgData name="Arey, Brian" userId="cd4c7147-d651-4cf6-916c-72cfa05ff466" providerId="ADAL" clId="{ECC16841-AF7F-4A6E-B5E5-DE157320AC34}" dt="2023-05-12T18:06:34.557" v="20" actId="21"/>
          <ac:spMkLst>
            <pc:docMk/>
            <pc:sldMk cId="1337482555" sldId="261"/>
            <ac:spMk id="54" creationId="{EBAF4EB3-F00D-4568-82BE-C494103A0D38}"/>
          </ac:spMkLst>
        </pc:spChg>
        <pc:grpChg chg="del">
          <ac:chgData name="Arey, Brian" userId="cd4c7147-d651-4cf6-916c-72cfa05ff466" providerId="ADAL" clId="{ECC16841-AF7F-4A6E-B5E5-DE157320AC34}" dt="2023-05-12T18:06:34.557" v="20" actId="21"/>
          <ac:grpSpMkLst>
            <pc:docMk/>
            <pc:sldMk cId="1337482555" sldId="261"/>
            <ac:grpSpMk id="68" creationId="{183CAEAE-4A3A-8686-F670-A2DD3C8C5422}"/>
          </ac:grpSpMkLst>
        </pc:grpChg>
        <pc:grpChg chg="del">
          <ac:chgData name="Arey, Brian" userId="cd4c7147-d651-4cf6-916c-72cfa05ff466" providerId="ADAL" clId="{ECC16841-AF7F-4A6E-B5E5-DE157320AC34}" dt="2023-05-12T18:06:34.557" v="20" actId="21"/>
          <ac:grpSpMkLst>
            <pc:docMk/>
            <pc:sldMk cId="1337482555" sldId="261"/>
            <ac:grpSpMk id="70" creationId="{5CF788FA-1890-B9A5-CB05-4B167F16CC8B}"/>
          </ac:grpSpMkLst>
        </pc:grpChg>
        <pc:picChg chg="del">
          <ac:chgData name="Arey, Brian" userId="cd4c7147-d651-4cf6-916c-72cfa05ff466" providerId="ADAL" clId="{ECC16841-AF7F-4A6E-B5E5-DE157320AC34}" dt="2023-05-12T18:06:34.557" v="20" actId="21"/>
          <ac:picMkLst>
            <pc:docMk/>
            <pc:sldMk cId="1337482555" sldId="261"/>
            <ac:picMk id="22" creationId="{5E40995B-AA95-4C03-A14D-D91CE9311A30}"/>
          </ac:picMkLst>
        </pc:picChg>
        <pc:picChg chg="del">
          <ac:chgData name="Arey, Brian" userId="cd4c7147-d651-4cf6-916c-72cfa05ff466" providerId="ADAL" clId="{ECC16841-AF7F-4A6E-B5E5-DE157320AC34}" dt="2023-05-12T18:06:34.557" v="20" actId="21"/>
          <ac:picMkLst>
            <pc:docMk/>
            <pc:sldMk cId="1337482555" sldId="261"/>
            <ac:picMk id="24" creationId="{D2481147-D81A-4DC6-B4E0-233A17FDF003}"/>
          </ac:picMkLst>
        </pc:picChg>
        <pc:picChg chg="mod">
          <ac:chgData name="Arey, Brian" userId="cd4c7147-d651-4cf6-916c-72cfa05ff466" providerId="ADAL" clId="{ECC16841-AF7F-4A6E-B5E5-DE157320AC34}" dt="2023-05-12T18:06:45.910" v="27" actId="1036"/>
          <ac:picMkLst>
            <pc:docMk/>
            <pc:sldMk cId="1337482555" sldId="261"/>
            <ac:picMk id="51" creationId="{54DEF7ED-0021-4B7F-E455-56766F166399}"/>
          </ac:picMkLst>
        </pc:picChg>
        <pc:picChg chg="del">
          <ac:chgData name="Arey, Brian" userId="cd4c7147-d651-4cf6-916c-72cfa05ff466" providerId="ADAL" clId="{ECC16841-AF7F-4A6E-B5E5-DE157320AC34}" dt="2023-05-12T18:06:34.557" v="20" actId="21"/>
          <ac:picMkLst>
            <pc:docMk/>
            <pc:sldMk cId="1337482555" sldId="261"/>
            <ac:picMk id="77" creationId="{1099436B-6E6C-4E00-A4E5-0184506D234E}"/>
          </ac:picMkLst>
        </pc:picChg>
        <pc:picChg chg="del">
          <ac:chgData name="Arey, Brian" userId="cd4c7147-d651-4cf6-916c-72cfa05ff466" providerId="ADAL" clId="{ECC16841-AF7F-4A6E-B5E5-DE157320AC34}" dt="2023-05-12T18:06:34.557" v="20" actId="21"/>
          <ac:picMkLst>
            <pc:docMk/>
            <pc:sldMk cId="1337482555" sldId="261"/>
            <ac:picMk id="83" creationId="{98E25C30-BE16-4FF9-48D9-DFB28BCEEF8D}"/>
          </ac:picMkLst>
        </pc:picChg>
      </pc:sldChg>
      <pc:sldChg chg="delSp modSp mod">
        <pc:chgData name="Arey, Brian" userId="cd4c7147-d651-4cf6-916c-72cfa05ff466" providerId="ADAL" clId="{ECC16841-AF7F-4A6E-B5E5-DE157320AC34}" dt="2023-05-12T18:07:47.579" v="66" actId="1035"/>
        <pc:sldMkLst>
          <pc:docMk/>
          <pc:sldMk cId="2795975650" sldId="262"/>
        </pc:sldMkLst>
        <pc:spChg chg="del">
          <ac:chgData name="Arey, Brian" userId="cd4c7147-d651-4cf6-916c-72cfa05ff466" providerId="ADAL" clId="{ECC16841-AF7F-4A6E-B5E5-DE157320AC34}" dt="2023-05-12T18:07:36.259" v="59" actId="21"/>
          <ac:spMkLst>
            <pc:docMk/>
            <pc:sldMk cId="2795975650" sldId="262"/>
            <ac:spMk id="26" creationId="{00000000-0000-0000-0000-000000000000}"/>
          </ac:spMkLst>
        </pc:spChg>
        <pc:spChg chg="del">
          <ac:chgData name="Arey, Brian" userId="cd4c7147-d651-4cf6-916c-72cfa05ff466" providerId="ADAL" clId="{ECC16841-AF7F-4A6E-B5E5-DE157320AC34}" dt="2023-05-12T18:07:36.259" v="59" actId="21"/>
          <ac:spMkLst>
            <pc:docMk/>
            <pc:sldMk cId="2795975650" sldId="262"/>
            <ac:spMk id="27" creationId="{00000000-0000-0000-0000-000000000000}"/>
          </ac:spMkLst>
        </pc:spChg>
        <pc:picChg chg="mod">
          <ac:chgData name="Arey, Brian" userId="cd4c7147-d651-4cf6-916c-72cfa05ff466" providerId="ADAL" clId="{ECC16841-AF7F-4A6E-B5E5-DE157320AC34}" dt="2023-05-12T18:07:47.579" v="66" actId="1035"/>
          <ac:picMkLst>
            <pc:docMk/>
            <pc:sldMk cId="2795975650" sldId="262"/>
            <ac:picMk id="3" creationId="{4D5C43C3-E57C-4FE1-193A-4649AA5F7347}"/>
          </ac:picMkLst>
        </pc:picChg>
        <pc:picChg chg="del">
          <ac:chgData name="Arey, Brian" userId="cd4c7147-d651-4cf6-916c-72cfa05ff466" providerId="ADAL" clId="{ECC16841-AF7F-4A6E-B5E5-DE157320AC34}" dt="2023-05-12T18:07:36.259" v="59" actId="21"/>
          <ac:picMkLst>
            <pc:docMk/>
            <pc:sldMk cId="2795975650" sldId="262"/>
            <ac:picMk id="20" creationId="{00000000-0000-0000-0000-000000000000}"/>
          </ac:picMkLst>
        </pc:picChg>
        <pc:picChg chg="del">
          <ac:chgData name="Arey, Brian" userId="cd4c7147-d651-4cf6-916c-72cfa05ff466" providerId="ADAL" clId="{ECC16841-AF7F-4A6E-B5E5-DE157320AC34}" dt="2023-05-12T18:07:36.259" v="59" actId="21"/>
          <ac:picMkLst>
            <pc:docMk/>
            <pc:sldMk cId="2795975650" sldId="262"/>
            <ac:picMk id="52" creationId="{1F35F353-E7E3-6C21-6513-08A4E7A87B11}"/>
          </ac:picMkLst>
        </pc:picChg>
      </pc:sldChg>
      <pc:sldChg chg="delSp modSp mod">
        <pc:chgData name="Arey, Brian" userId="cd4c7147-d651-4cf6-916c-72cfa05ff466" providerId="ADAL" clId="{ECC16841-AF7F-4A6E-B5E5-DE157320AC34}" dt="2023-05-12T18:08:30.469" v="69" actId="1076"/>
        <pc:sldMkLst>
          <pc:docMk/>
          <pc:sldMk cId="1616941183" sldId="263"/>
        </pc:sldMkLst>
        <pc:spChg chg="del">
          <ac:chgData name="Arey, Brian" userId="cd4c7147-d651-4cf6-916c-72cfa05ff466" providerId="ADAL" clId="{ECC16841-AF7F-4A6E-B5E5-DE157320AC34}" dt="2023-05-12T18:08:18.984" v="68" actId="21"/>
          <ac:spMkLst>
            <pc:docMk/>
            <pc:sldMk cId="1616941183" sldId="263"/>
            <ac:spMk id="10" creationId="{00000000-0000-0000-0000-000000000000}"/>
          </ac:spMkLst>
        </pc:spChg>
        <pc:spChg chg="del">
          <ac:chgData name="Arey, Brian" userId="cd4c7147-d651-4cf6-916c-72cfa05ff466" providerId="ADAL" clId="{ECC16841-AF7F-4A6E-B5E5-DE157320AC34}" dt="2023-05-12T18:08:18.984" v="68" actId="21"/>
          <ac:spMkLst>
            <pc:docMk/>
            <pc:sldMk cId="1616941183" sldId="263"/>
            <ac:spMk id="11" creationId="{00000000-0000-0000-0000-000000000000}"/>
          </ac:spMkLst>
        </pc:spChg>
        <pc:picChg chg="mod">
          <ac:chgData name="Arey, Brian" userId="cd4c7147-d651-4cf6-916c-72cfa05ff466" providerId="ADAL" clId="{ECC16841-AF7F-4A6E-B5E5-DE157320AC34}" dt="2023-05-12T18:08:30.469" v="69" actId="1076"/>
          <ac:picMkLst>
            <pc:docMk/>
            <pc:sldMk cId="1616941183" sldId="263"/>
            <ac:picMk id="3" creationId="{B22068FD-2891-5A67-8250-31CCA7DD851D}"/>
          </ac:picMkLst>
        </pc:picChg>
        <pc:picChg chg="del">
          <ac:chgData name="Arey, Brian" userId="cd4c7147-d651-4cf6-916c-72cfa05ff466" providerId="ADAL" clId="{ECC16841-AF7F-4A6E-B5E5-DE157320AC34}" dt="2023-05-12T18:08:18.984" v="68" actId="21"/>
          <ac:picMkLst>
            <pc:docMk/>
            <pc:sldMk cId="1616941183" sldId="263"/>
            <ac:picMk id="6" creationId="{1CBD84FC-87C4-1133-BAA9-05E7CD0FABFE}"/>
          </ac:picMkLst>
        </pc:picChg>
        <pc:picChg chg="del">
          <ac:chgData name="Arey, Brian" userId="cd4c7147-d651-4cf6-916c-72cfa05ff466" providerId="ADAL" clId="{ECC16841-AF7F-4A6E-B5E5-DE157320AC34}" dt="2023-05-12T18:08:18.984" v="68" actId="21"/>
          <ac:picMkLst>
            <pc:docMk/>
            <pc:sldMk cId="1616941183" sldId="263"/>
            <ac:picMk id="7" creationId="{56AF0013-7B7B-EE6D-018A-A3E2B914FB77}"/>
          </ac:picMkLst>
        </pc:picChg>
      </pc:sldChg>
      <pc:sldChg chg="delSp modSp mod">
        <pc:chgData name="Arey, Brian" userId="cd4c7147-d651-4cf6-916c-72cfa05ff466" providerId="ADAL" clId="{ECC16841-AF7F-4A6E-B5E5-DE157320AC34}" dt="2023-05-12T18:09:53.520" v="80" actId="21"/>
        <pc:sldMkLst>
          <pc:docMk/>
          <pc:sldMk cId="2231728804" sldId="265"/>
        </pc:sldMkLst>
        <pc:picChg chg="del mod">
          <ac:chgData name="Arey, Brian" userId="cd4c7147-d651-4cf6-916c-72cfa05ff466" providerId="ADAL" clId="{ECC16841-AF7F-4A6E-B5E5-DE157320AC34}" dt="2023-05-12T18:09:53.520" v="80" actId="21"/>
          <ac:picMkLst>
            <pc:docMk/>
            <pc:sldMk cId="2231728804" sldId="265"/>
            <ac:picMk id="5" creationId="{8CBB5CC4-5778-2ED8-AC97-63287B88ADFC}"/>
          </ac:picMkLst>
        </pc:picChg>
      </pc:sldChg>
      <pc:sldChg chg="delSp modSp mod">
        <pc:chgData name="Arey, Brian" userId="cd4c7147-d651-4cf6-916c-72cfa05ff466" providerId="ADAL" clId="{ECC16841-AF7F-4A6E-B5E5-DE157320AC34}" dt="2023-05-12T18:11:59.020" v="91" actId="1036"/>
        <pc:sldMkLst>
          <pc:docMk/>
          <pc:sldMk cId="4206795478" sldId="266"/>
        </pc:sldMkLst>
        <pc:spChg chg="del">
          <ac:chgData name="Arey, Brian" userId="cd4c7147-d651-4cf6-916c-72cfa05ff466" providerId="ADAL" clId="{ECC16841-AF7F-4A6E-B5E5-DE157320AC34}" dt="2023-05-12T18:08:02.291" v="67" actId="21"/>
          <ac:spMkLst>
            <pc:docMk/>
            <pc:sldMk cId="4206795478" sldId="266"/>
            <ac:spMk id="7" creationId="{00000000-0000-0000-0000-000000000000}"/>
          </ac:spMkLst>
        </pc:spChg>
        <pc:spChg chg="del">
          <ac:chgData name="Arey, Brian" userId="cd4c7147-d651-4cf6-916c-72cfa05ff466" providerId="ADAL" clId="{ECC16841-AF7F-4A6E-B5E5-DE157320AC34}" dt="2023-05-12T18:08:02.291" v="67" actId="21"/>
          <ac:spMkLst>
            <pc:docMk/>
            <pc:sldMk cId="4206795478" sldId="266"/>
            <ac:spMk id="8" creationId="{00000000-0000-0000-0000-000000000000}"/>
          </ac:spMkLst>
        </pc:spChg>
        <pc:spChg chg="del">
          <ac:chgData name="Arey, Brian" userId="cd4c7147-d651-4cf6-916c-72cfa05ff466" providerId="ADAL" clId="{ECC16841-AF7F-4A6E-B5E5-DE157320AC34}" dt="2023-05-12T18:08:02.291" v="67" actId="21"/>
          <ac:spMkLst>
            <pc:docMk/>
            <pc:sldMk cId="4206795478" sldId="266"/>
            <ac:spMk id="12" creationId="{00000000-0000-0000-0000-000000000000}"/>
          </ac:spMkLst>
        </pc:spChg>
        <pc:picChg chg="mod">
          <ac:chgData name="Arey, Brian" userId="cd4c7147-d651-4cf6-916c-72cfa05ff466" providerId="ADAL" clId="{ECC16841-AF7F-4A6E-B5E5-DE157320AC34}" dt="2023-05-12T18:11:59.020" v="91" actId="1036"/>
          <ac:picMkLst>
            <pc:docMk/>
            <pc:sldMk cId="4206795478" sldId="266"/>
            <ac:picMk id="2" creationId="{CCA21FCA-9D6F-6967-DF3C-116BB4E6B05B}"/>
          </ac:picMkLst>
        </pc:picChg>
        <pc:picChg chg="del">
          <ac:chgData name="Arey, Brian" userId="cd4c7147-d651-4cf6-916c-72cfa05ff466" providerId="ADAL" clId="{ECC16841-AF7F-4A6E-B5E5-DE157320AC34}" dt="2023-05-12T18:08:02.291" v="67" actId="21"/>
          <ac:picMkLst>
            <pc:docMk/>
            <pc:sldMk cId="4206795478" sldId="266"/>
            <ac:picMk id="3" creationId="{06104E3A-633F-8244-3F7A-3485F16F5E3E}"/>
          </ac:picMkLst>
        </pc:picChg>
        <pc:picChg chg="del">
          <ac:chgData name="Arey, Brian" userId="cd4c7147-d651-4cf6-916c-72cfa05ff466" providerId="ADAL" clId="{ECC16841-AF7F-4A6E-B5E5-DE157320AC34}" dt="2023-05-12T18:08:02.291" v="67" actId="21"/>
          <ac:picMkLst>
            <pc:docMk/>
            <pc:sldMk cId="4206795478" sldId="266"/>
            <ac:picMk id="4" creationId="{8F4E182B-C6D8-6433-4B12-1158167DAF1F}"/>
          </ac:picMkLst>
        </pc:picChg>
        <pc:picChg chg="del">
          <ac:chgData name="Arey, Brian" userId="cd4c7147-d651-4cf6-916c-72cfa05ff466" providerId="ADAL" clId="{ECC16841-AF7F-4A6E-B5E5-DE157320AC34}" dt="2023-05-12T18:08:02.291" v="67" actId="21"/>
          <ac:picMkLst>
            <pc:docMk/>
            <pc:sldMk cId="4206795478" sldId="266"/>
            <ac:picMk id="14" creationId="{9E8FE5B7-EEFD-C2B4-37CD-7DC0F0E3FA06}"/>
          </ac:picMkLst>
        </pc:picChg>
      </pc:sldChg>
      <pc:sldChg chg="delSp mod">
        <pc:chgData name="Arey, Brian" userId="cd4c7147-d651-4cf6-916c-72cfa05ff466" providerId="ADAL" clId="{ECC16841-AF7F-4A6E-B5E5-DE157320AC34}" dt="2023-05-12T18:06:05.668" v="19" actId="21"/>
        <pc:sldMkLst>
          <pc:docMk/>
          <pc:sldMk cId="4286344101" sldId="268"/>
        </pc:sldMkLst>
        <pc:spChg chg="del">
          <ac:chgData name="Arey, Brian" userId="cd4c7147-d651-4cf6-916c-72cfa05ff466" providerId="ADAL" clId="{ECC16841-AF7F-4A6E-B5E5-DE157320AC34}" dt="2023-05-12T18:06:05.668" v="19" actId="21"/>
          <ac:spMkLst>
            <pc:docMk/>
            <pc:sldMk cId="4286344101" sldId="268"/>
            <ac:spMk id="10" creationId="{00000000-0000-0000-0000-000000000000}"/>
          </ac:spMkLst>
        </pc:spChg>
        <pc:spChg chg="del">
          <ac:chgData name="Arey, Brian" userId="cd4c7147-d651-4cf6-916c-72cfa05ff466" providerId="ADAL" clId="{ECC16841-AF7F-4A6E-B5E5-DE157320AC34}" dt="2023-05-12T18:06:05.668" v="19" actId="21"/>
          <ac:spMkLst>
            <pc:docMk/>
            <pc:sldMk cId="4286344101" sldId="268"/>
            <ac:spMk id="12" creationId="{00000000-0000-0000-0000-000000000000}"/>
          </ac:spMkLst>
        </pc:spChg>
        <pc:picChg chg="del">
          <ac:chgData name="Arey, Brian" userId="cd4c7147-d651-4cf6-916c-72cfa05ff466" providerId="ADAL" clId="{ECC16841-AF7F-4A6E-B5E5-DE157320AC34}" dt="2023-05-12T18:06:05.668" v="19" actId="21"/>
          <ac:picMkLst>
            <pc:docMk/>
            <pc:sldMk cId="4286344101" sldId="268"/>
            <ac:picMk id="16" creationId="{0CC75B7D-15A7-E6EA-3BA9-CE7DE54878CD}"/>
          </ac:picMkLst>
        </pc:picChg>
        <pc:picChg chg="del">
          <ac:chgData name="Arey, Brian" userId="cd4c7147-d651-4cf6-916c-72cfa05ff466" providerId="ADAL" clId="{ECC16841-AF7F-4A6E-B5E5-DE157320AC34}" dt="2023-05-12T18:06:05.668" v="19" actId="21"/>
          <ac:picMkLst>
            <pc:docMk/>
            <pc:sldMk cId="4286344101" sldId="268"/>
            <ac:picMk id="19" creationId="{02A6274E-1276-40B0-A1DF-CA92D0841E92}"/>
          </ac:picMkLst>
        </pc:picChg>
      </pc:sldChg>
      <pc:sldChg chg="delSp modSp mod">
        <pc:chgData name="Arey, Brian" userId="cd4c7147-d651-4cf6-916c-72cfa05ff466" providerId="ADAL" clId="{ECC16841-AF7F-4A6E-B5E5-DE157320AC34}" dt="2023-05-12T18:50:05.893" v="118" actId="20577"/>
        <pc:sldMkLst>
          <pc:docMk/>
          <pc:sldMk cId="1202135131" sldId="269"/>
        </pc:sldMkLst>
        <pc:spChg chg="mod">
          <ac:chgData name="Arey, Brian" userId="cd4c7147-d651-4cf6-916c-72cfa05ff466" providerId="ADAL" clId="{ECC16841-AF7F-4A6E-B5E5-DE157320AC34}" dt="2023-05-12T18:50:05.893" v="118" actId="20577"/>
          <ac:spMkLst>
            <pc:docMk/>
            <pc:sldMk cId="1202135131" sldId="269"/>
            <ac:spMk id="2" creationId="{A73FD9B7-A5E5-46B2-85A0-25EFFBB30E75}"/>
          </ac:spMkLst>
        </pc:spChg>
        <pc:spChg chg="del">
          <ac:chgData name="Arey, Brian" userId="cd4c7147-d651-4cf6-916c-72cfa05ff466" providerId="ADAL" clId="{ECC16841-AF7F-4A6E-B5E5-DE157320AC34}" dt="2023-05-12T18:10:20.560" v="81" actId="21"/>
          <ac:spMkLst>
            <pc:docMk/>
            <pc:sldMk cId="1202135131" sldId="269"/>
            <ac:spMk id="4" creationId="{5166F4EA-41AE-464D-B4A0-956E77D7A9A0}"/>
          </ac:spMkLst>
        </pc:spChg>
        <pc:grpChg chg="del">
          <ac:chgData name="Arey, Brian" userId="cd4c7147-d651-4cf6-916c-72cfa05ff466" providerId="ADAL" clId="{ECC16841-AF7F-4A6E-B5E5-DE157320AC34}" dt="2023-05-12T18:10:20.560" v="81" actId="21"/>
          <ac:grpSpMkLst>
            <pc:docMk/>
            <pc:sldMk cId="1202135131" sldId="269"/>
            <ac:grpSpMk id="7" creationId="{375F46E6-8F25-0EBB-6D44-F8AEB530EB60}"/>
          </ac:grpSpMkLst>
        </pc:grpChg>
        <pc:picChg chg="del">
          <ac:chgData name="Arey, Brian" userId="cd4c7147-d651-4cf6-916c-72cfa05ff466" providerId="ADAL" clId="{ECC16841-AF7F-4A6E-B5E5-DE157320AC34}" dt="2023-05-12T18:10:20.560" v="81" actId="21"/>
          <ac:picMkLst>
            <pc:docMk/>
            <pc:sldMk cId="1202135131" sldId="269"/>
            <ac:picMk id="3" creationId="{E0A1D7B2-EB46-4E72-A5F4-BB0DAF54ACA3}"/>
          </ac:picMkLst>
        </pc:picChg>
        <pc:picChg chg="mod">
          <ac:chgData name="Arey, Brian" userId="cd4c7147-d651-4cf6-916c-72cfa05ff466" providerId="ADAL" clId="{ECC16841-AF7F-4A6E-B5E5-DE157320AC34}" dt="2023-05-12T18:10:30.941" v="82" actId="1076"/>
          <ac:picMkLst>
            <pc:docMk/>
            <pc:sldMk cId="1202135131" sldId="269"/>
            <ac:picMk id="8" creationId="{6AF3E3F4-7AB3-25BB-943A-938DC3F6E300}"/>
          </ac:picMkLst>
        </pc:picChg>
      </pc:sldChg>
      <pc:sldChg chg="delSp modSp mod">
        <pc:chgData name="Arey, Brian" userId="cd4c7147-d651-4cf6-916c-72cfa05ff466" providerId="ADAL" clId="{ECC16841-AF7F-4A6E-B5E5-DE157320AC34}" dt="2023-05-12T18:09:45.958" v="76" actId="1076"/>
        <pc:sldMkLst>
          <pc:docMk/>
          <pc:sldMk cId="3330150030" sldId="271"/>
        </pc:sldMkLst>
        <pc:picChg chg="mod">
          <ac:chgData name="Arey, Brian" userId="cd4c7147-d651-4cf6-916c-72cfa05ff466" providerId="ADAL" clId="{ECC16841-AF7F-4A6E-B5E5-DE157320AC34}" dt="2023-05-12T18:09:45.958" v="76" actId="1076"/>
          <ac:picMkLst>
            <pc:docMk/>
            <pc:sldMk cId="3330150030" sldId="271"/>
            <ac:picMk id="2" creationId="{3CBAED3D-B0E1-0F4E-EB3C-C195CF17E8A7}"/>
          </ac:picMkLst>
        </pc:picChg>
        <pc:picChg chg="del">
          <ac:chgData name="Arey, Brian" userId="cd4c7147-d651-4cf6-916c-72cfa05ff466" providerId="ADAL" clId="{ECC16841-AF7F-4A6E-B5E5-DE157320AC34}" dt="2023-05-12T18:09:37.349" v="75" actId="21"/>
          <ac:picMkLst>
            <pc:docMk/>
            <pc:sldMk cId="3330150030" sldId="271"/>
            <ac:picMk id="4" creationId="{CDA82FA9-6B63-8AA9-5CB6-262D12A24299}"/>
          </ac:picMkLst>
        </pc:picChg>
      </pc:sldChg>
      <pc:sldChg chg="delSp modSp mod">
        <pc:chgData name="Arey, Brian" userId="cd4c7147-d651-4cf6-916c-72cfa05ff466" providerId="ADAL" clId="{ECC16841-AF7F-4A6E-B5E5-DE157320AC34}" dt="2023-05-12T18:59:38.214" v="119" actId="1076"/>
        <pc:sldMkLst>
          <pc:docMk/>
          <pc:sldMk cId="2474477106" sldId="272"/>
        </pc:sldMkLst>
        <pc:picChg chg="mod">
          <ac:chgData name="Arey, Brian" userId="cd4c7147-d651-4cf6-916c-72cfa05ff466" providerId="ADAL" clId="{ECC16841-AF7F-4A6E-B5E5-DE157320AC34}" dt="2023-05-12T18:59:38.214" v="119" actId="1076"/>
          <ac:picMkLst>
            <pc:docMk/>
            <pc:sldMk cId="2474477106" sldId="272"/>
            <ac:picMk id="3" creationId="{3199F9F4-6E58-44C3-4151-C548184DDD14}"/>
          </ac:picMkLst>
        </pc:picChg>
        <pc:picChg chg="del">
          <ac:chgData name="Arey, Brian" userId="cd4c7147-d651-4cf6-916c-72cfa05ff466" providerId="ADAL" clId="{ECC16841-AF7F-4A6E-B5E5-DE157320AC34}" dt="2023-05-12T18:10:41.398" v="83" actId="21"/>
          <ac:picMkLst>
            <pc:docMk/>
            <pc:sldMk cId="2474477106" sldId="272"/>
            <ac:picMk id="6" creationId="{6089D7B4-DF22-A3F4-B32F-559BFD6086EE}"/>
          </ac:picMkLst>
        </pc:picChg>
      </pc:sldChg>
      <pc:sldChg chg="delSp modSp mod">
        <pc:chgData name="Arey, Brian" userId="cd4c7147-d651-4cf6-916c-72cfa05ff466" providerId="ADAL" clId="{ECC16841-AF7F-4A6E-B5E5-DE157320AC34}" dt="2023-05-12T18:31:38.700" v="114" actId="1035"/>
        <pc:sldMkLst>
          <pc:docMk/>
          <pc:sldMk cId="1779941918" sldId="273"/>
        </pc:sldMkLst>
        <pc:spChg chg="del">
          <ac:chgData name="Arey, Brian" userId="cd4c7147-d651-4cf6-916c-72cfa05ff466" providerId="ADAL" clId="{ECC16841-AF7F-4A6E-B5E5-DE157320AC34}" dt="2023-05-12T18:04:38" v="0" actId="21"/>
          <ac:spMkLst>
            <pc:docMk/>
            <pc:sldMk cId="1779941918" sldId="273"/>
            <ac:spMk id="19" creationId="{42416DFC-194A-4F96-8FAC-BABA6AA797FD}"/>
          </ac:spMkLst>
        </pc:spChg>
        <pc:spChg chg="del">
          <ac:chgData name="Arey, Brian" userId="cd4c7147-d651-4cf6-916c-72cfa05ff466" providerId="ADAL" clId="{ECC16841-AF7F-4A6E-B5E5-DE157320AC34}" dt="2023-05-12T18:04:38" v="0" actId="21"/>
          <ac:spMkLst>
            <pc:docMk/>
            <pc:sldMk cId="1779941918" sldId="273"/>
            <ac:spMk id="20" creationId="{43EE687F-B9B5-30D2-059D-10DAF42C4F51}"/>
          </ac:spMkLst>
        </pc:spChg>
        <pc:spChg chg="del">
          <ac:chgData name="Arey, Brian" userId="cd4c7147-d651-4cf6-916c-72cfa05ff466" providerId="ADAL" clId="{ECC16841-AF7F-4A6E-B5E5-DE157320AC34}" dt="2023-05-12T18:04:38" v="0" actId="21"/>
          <ac:spMkLst>
            <pc:docMk/>
            <pc:sldMk cId="1779941918" sldId="273"/>
            <ac:spMk id="21" creationId="{0D6A3AA5-3978-4BE5-A643-4122C6F7C175}"/>
          </ac:spMkLst>
        </pc:spChg>
        <pc:spChg chg="del">
          <ac:chgData name="Arey, Brian" userId="cd4c7147-d651-4cf6-916c-72cfa05ff466" providerId="ADAL" clId="{ECC16841-AF7F-4A6E-B5E5-DE157320AC34}" dt="2023-05-12T18:04:38" v="0" actId="21"/>
          <ac:spMkLst>
            <pc:docMk/>
            <pc:sldMk cId="1779941918" sldId="273"/>
            <ac:spMk id="27" creationId="{4B9FF0A7-77CF-A763-A633-CFC8F4DCBFCB}"/>
          </ac:spMkLst>
        </pc:spChg>
        <pc:picChg chg="del">
          <ac:chgData name="Arey, Brian" userId="cd4c7147-d651-4cf6-916c-72cfa05ff466" providerId="ADAL" clId="{ECC16841-AF7F-4A6E-B5E5-DE157320AC34}" dt="2023-05-12T18:04:38" v="0" actId="21"/>
          <ac:picMkLst>
            <pc:docMk/>
            <pc:sldMk cId="1779941918" sldId="273"/>
            <ac:picMk id="15" creationId="{305D0841-CA84-94B9-4E96-D6C40BED4DF5}"/>
          </ac:picMkLst>
        </pc:picChg>
        <pc:picChg chg="del">
          <ac:chgData name="Arey, Brian" userId="cd4c7147-d651-4cf6-916c-72cfa05ff466" providerId="ADAL" clId="{ECC16841-AF7F-4A6E-B5E5-DE157320AC34}" dt="2023-05-12T18:04:38" v="0" actId="21"/>
          <ac:picMkLst>
            <pc:docMk/>
            <pc:sldMk cId="1779941918" sldId="273"/>
            <ac:picMk id="16" creationId="{AD070406-11B5-D136-0068-719CE5288138}"/>
          </ac:picMkLst>
        </pc:picChg>
        <pc:picChg chg="del">
          <ac:chgData name="Arey, Brian" userId="cd4c7147-d651-4cf6-916c-72cfa05ff466" providerId="ADAL" clId="{ECC16841-AF7F-4A6E-B5E5-DE157320AC34}" dt="2023-05-12T18:04:38" v="0" actId="21"/>
          <ac:picMkLst>
            <pc:docMk/>
            <pc:sldMk cId="1779941918" sldId="273"/>
            <ac:picMk id="18" creationId="{C494110B-45E8-FEEA-816A-B330577C745A}"/>
          </ac:picMkLst>
        </pc:picChg>
        <pc:picChg chg="del">
          <ac:chgData name="Arey, Brian" userId="cd4c7147-d651-4cf6-916c-72cfa05ff466" providerId="ADAL" clId="{ECC16841-AF7F-4A6E-B5E5-DE157320AC34}" dt="2023-05-12T18:04:38" v="0" actId="21"/>
          <ac:picMkLst>
            <pc:docMk/>
            <pc:sldMk cId="1779941918" sldId="273"/>
            <ac:picMk id="26" creationId="{5787F5B5-6C44-8FE0-6F39-D135375CD041}"/>
          </ac:picMkLst>
        </pc:picChg>
        <pc:picChg chg="mod">
          <ac:chgData name="Arey, Brian" userId="cd4c7147-d651-4cf6-916c-72cfa05ff466" providerId="ADAL" clId="{ECC16841-AF7F-4A6E-B5E5-DE157320AC34}" dt="2023-05-12T18:31:38.700" v="114" actId="1035"/>
          <ac:picMkLst>
            <pc:docMk/>
            <pc:sldMk cId="1779941918" sldId="273"/>
            <ac:picMk id="28" creationId="{18D43A51-BA82-2EDE-9E10-F5DE7C72B7DA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38258" cy="465292"/>
          </a:xfrm>
          <a:prstGeom prst="rect">
            <a:avLst/>
          </a:prstGeom>
        </p:spPr>
        <p:txBody>
          <a:bodyPr vert="horz" lIns="90416" tIns="45208" rIns="90416" bIns="4520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576" y="0"/>
            <a:ext cx="3038258" cy="465292"/>
          </a:xfrm>
          <a:prstGeom prst="rect">
            <a:avLst/>
          </a:prstGeom>
        </p:spPr>
        <p:txBody>
          <a:bodyPr vert="horz" lIns="90416" tIns="45208" rIns="90416" bIns="45208" rtlCol="0"/>
          <a:lstStyle>
            <a:lvl1pPr algn="r">
              <a:defRPr sz="1200"/>
            </a:lvl1pPr>
          </a:lstStyle>
          <a:p>
            <a:fld id="{13FE983D-9EAA-47CF-B86A-6E0C18752650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416" tIns="45208" rIns="90416" bIns="4520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0413" y="4473716"/>
            <a:ext cx="5609574" cy="3661028"/>
          </a:xfrm>
          <a:prstGeom prst="rect">
            <a:avLst/>
          </a:prstGeom>
        </p:spPr>
        <p:txBody>
          <a:bodyPr vert="horz" lIns="90416" tIns="45208" rIns="90416" bIns="45208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31108"/>
            <a:ext cx="3038258" cy="465292"/>
          </a:xfrm>
          <a:prstGeom prst="rect">
            <a:avLst/>
          </a:prstGeom>
        </p:spPr>
        <p:txBody>
          <a:bodyPr vert="horz" lIns="90416" tIns="45208" rIns="90416" bIns="4520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576" y="8831108"/>
            <a:ext cx="3038258" cy="465292"/>
          </a:xfrm>
          <a:prstGeom prst="rect">
            <a:avLst/>
          </a:prstGeom>
        </p:spPr>
        <p:txBody>
          <a:bodyPr vert="horz" lIns="90416" tIns="45208" rIns="90416" bIns="45208" rtlCol="0" anchor="b"/>
          <a:lstStyle>
            <a:lvl1pPr algn="r">
              <a:defRPr sz="1200"/>
            </a:lvl1pPr>
          </a:lstStyle>
          <a:p>
            <a:fld id="{55B75808-D628-4622-928C-5A06A96322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48561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B75808-D628-4622-928C-5A06A963223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800169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B75808-D628-4622-928C-5A06A963223E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24419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B75808-D628-4622-928C-5A06A963223E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339256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B75808-D628-4622-928C-5A06A963223E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362882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B75808-D628-4622-928C-5A06A963223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531129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B75808-D628-4622-928C-5A06A963223E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76844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B75808-D628-4622-928C-5A06A963223E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31334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B75808-D628-4622-928C-5A06A963223E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498450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B75808-D628-4622-928C-5A06A963223E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251856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B75808-D628-4622-928C-5A06A963223E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018398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B75808-D628-4622-928C-5A06A963223E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8389661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B75808-D628-4622-928C-5A06A963223E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71058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880BB-4ED6-402A-9AB9-9E6472F990BD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52312-0AFB-4DAF-ADAD-B803611B79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71309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880BB-4ED6-402A-9AB9-9E6472F990BD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52312-0AFB-4DAF-ADAD-B803611B79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0743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880BB-4ED6-402A-9AB9-9E6472F990BD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52312-0AFB-4DAF-ADAD-B803611B79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1159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880BB-4ED6-402A-9AB9-9E6472F990BD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52312-0AFB-4DAF-ADAD-B803611B79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9432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880BB-4ED6-402A-9AB9-9E6472F990BD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52312-0AFB-4DAF-ADAD-B803611B79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934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880BB-4ED6-402A-9AB9-9E6472F990BD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52312-0AFB-4DAF-ADAD-B803611B79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131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880BB-4ED6-402A-9AB9-9E6472F990BD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52312-0AFB-4DAF-ADAD-B803611B79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43294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880BB-4ED6-402A-9AB9-9E6472F990BD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52312-0AFB-4DAF-ADAD-B803611B79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24632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880BB-4ED6-402A-9AB9-9E6472F990BD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52312-0AFB-4DAF-ADAD-B803611B79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6310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880BB-4ED6-402A-9AB9-9E6472F990BD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52312-0AFB-4DAF-ADAD-B803611B79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734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880BB-4ED6-402A-9AB9-9E6472F990BD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352312-0AFB-4DAF-ADAD-B803611B79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8984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7880BB-4ED6-402A-9AB9-9E6472F990BD}" type="datetimeFigureOut">
              <a:rPr lang="en-US" smtClean="0"/>
              <a:t>5/4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352312-0AFB-4DAF-ADAD-B803611B799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47015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84779" y="104712"/>
            <a:ext cx="485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igure 1. Primary siRNA screening results for alteration of KLF2 expression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37A4F797-F1C9-F89D-4F83-CBAB681367A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876130"/>
            <a:ext cx="12192000" cy="51057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634410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A97B359-4436-F56E-57F8-78AF22606B69}"/>
              </a:ext>
            </a:extLst>
          </p:cNvPr>
          <p:cNvSpPr txBox="1"/>
          <p:nvPr/>
        </p:nvSpPr>
        <p:spPr>
          <a:xfrm>
            <a:off x="100448" y="5960636"/>
            <a:ext cx="59955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l Figure 1. Target Identification Strategy and Targets Derived from Bioinformatic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4A59F69-9822-ED07-9551-7C6728FF9F1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81783" y="0"/>
            <a:ext cx="802843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660998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4779" y="66612"/>
            <a:ext cx="41092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l Figure 2. Validation of 96 well Orbital Flow Assay</a:t>
            </a:r>
          </a:p>
        </p:txBody>
      </p:sp>
      <p:sp>
        <p:nvSpPr>
          <p:cNvPr id="8" name="Rectangle 11"/>
          <p:cNvSpPr>
            <a:spLocks noChangeArrowheads="1"/>
          </p:cNvSpPr>
          <p:nvPr/>
        </p:nvSpPr>
        <p:spPr bwMode="auto">
          <a:xfrm>
            <a:off x="6354417" y="96696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9FC629B-CBFF-AEC3-CC85-D48E1F4D6B6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8417" y="496415"/>
            <a:ext cx="12192000" cy="50813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695517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37121F0-FED5-B806-B83F-C14639E91D37}"/>
              </a:ext>
            </a:extLst>
          </p:cNvPr>
          <p:cNvSpPr txBox="1"/>
          <p:nvPr/>
        </p:nvSpPr>
        <p:spPr>
          <a:xfrm>
            <a:off x="84779" y="66612"/>
            <a:ext cx="63802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l Figure 3. Time-course of Orbital Flow Effects on LGR4 and KLF2 Expression in HUVECs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CBAED3D-B0E1-0F4E-EB3C-C195CF17E8A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47535" y="795385"/>
            <a:ext cx="6822015" cy="32860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3015003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4779" y="66612"/>
            <a:ext cx="63147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l Figure 4. Overexpression of LGR4 in EA-hy926 cells stimulates KLF2 promoter activity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3555020-0F5F-21EA-901F-ABD4A7AC756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07431" y="1343987"/>
            <a:ext cx="5377138" cy="41700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3172880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73FD9B7-A5E5-46B2-85A0-25EFFBB30E75}"/>
              </a:ext>
            </a:extLst>
          </p:cNvPr>
          <p:cNvSpPr txBox="1"/>
          <p:nvPr/>
        </p:nvSpPr>
        <p:spPr>
          <a:xfrm>
            <a:off x="84779" y="66612"/>
            <a:ext cx="58184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l Figure 5. Structures of Putative LGR4 Agonists Compound 1 and Compound 2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6AF3E3F4-7AB3-25BB-943A-938DC3F6E30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21286" y="1172924"/>
            <a:ext cx="6474513" cy="27922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213513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0BF0339-B3B5-6CAE-F1EC-3B8F6187C7F8}"/>
              </a:ext>
            </a:extLst>
          </p:cNvPr>
          <p:cNvSpPr txBox="1"/>
          <p:nvPr/>
        </p:nvSpPr>
        <p:spPr>
          <a:xfrm>
            <a:off x="88135" y="98482"/>
            <a:ext cx="5733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upplemental Figure 6. Effect of Resolvin,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vD5</a:t>
            </a:r>
            <a:r>
              <a:rPr lang="en-US" sz="1400" baseline="-25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-3DPA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on KLF2 Expression in HUVEC cells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US" sz="12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199F9F4-6E58-44C3-4151-C548184DDD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73307" y="717398"/>
            <a:ext cx="5645385" cy="43346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44771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62183" y="-16856"/>
            <a:ext cx="5595443" cy="409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tabLst>
                <a:tab pos="171450" algn="l"/>
              </a:tabLst>
            </a:pP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2. Effect of Targeted Knockdown of Select GPCRs on Endothelial KLF2 Expression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508E522-8828-9A23-995D-AD66107634C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29192" y="344156"/>
            <a:ext cx="10333616" cy="61696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08081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01B43A9F-7863-30B7-2074-5D6C853E4300}"/>
              </a:ext>
            </a:extLst>
          </p:cNvPr>
          <p:cNvSpPr txBox="1"/>
          <p:nvPr/>
        </p:nvSpPr>
        <p:spPr>
          <a:xfrm>
            <a:off x="84779" y="66612"/>
            <a:ext cx="65054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igure 3. Effects of KD of SSTR3, GPR116, LGR4 and GPR101 on Orbital Shear- induced KLF2 Expression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18D43A51-BA82-2EDE-9E10-F5DE7C72B7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4171" y="334582"/>
            <a:ext cx="10083658" cy="59928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99419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62233" y="45210"/>
            <a:ext cx="8037521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4. SSTR3 is Present in Endothelial Cells and Agonists Positively Affect KLF2 Expression and Improve Endothelial Function</a:t>
            </a:r>
            <a:endParaRPr lang="en-US" sz="1200" dirty="0"/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A82CDA96-B636-03D7-0B45-02BCE7DB398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63188"/>
            <a:ext cx="12192000" cy="63316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97777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6890" y="78724"/>
            <a:ext cx="82922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5. Knockdown of the Class A Orphan Receptor GPR101 Positively Affects KLF2 Expression and Improves Endothelial Function</a:t>
            </a:r>
            <a:endParaRPr lang="en-US" sz="1200" dirty="0"/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54DEF7ED-0021-4B7F-E455-56766F16639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437" y="434724"/>
            <a:ext cx="12071126" cy="62062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74825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6890" y="78724"/>
            <a:ext cx="71590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6. LGR4 is Expressed in Endothelial Cells in a Flow-dependent Manner and Can Modulate KLF2 Expression</a:t>
            </a:r>
            <a:endParaRPr lang="en-US" sz="1200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3BE873D0-6499-3327-35AF-8CCE8BBB1C4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95256" y="581352"/>
            <a:ext cx="9000000" cy="52380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45736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12417" y="-21313"/>
            <a:ext cx="3828805" cy="409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tabLst>
                <a:tab pos="171450" algn="l"/>
              </a:tabLst>
            </a:pP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7. Identification of Small Molecule Agonists to LGR4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D5C43C3-E57C-4FE1-193A-4649AA5F734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5526" y="460438"/>
            <a:ext cx="11680948" cy="56758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597565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116718" y="-34402"/>
            <a:ext cx="5280997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8. Compound 1 and Compound 2 Improve Endothelial Cell Function in vitro</a:t>
            </a:r>
            <a:endParaRPr lang="en-US" sz="1200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CA21FCA-9D6F-6967-DF3C-116BB4E6B05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15357" y="87088"/>
            <a:ext cx="956128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679547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8723" y="102946"/>
            <a:ext cx="5612370" cy="276999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Figure 9. LGR4 Synthetic Agonists Do Not Activate the Canonical </a:t>
            </a:r>
            <a:r>
              <a:rPr lang="en-US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nt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Signaling Pathway</a:t>
            </a:r>
            <a:endParaRPr lang="en-US" sz="12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22068FD-2891-5A67-8250-31CCA7DD851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64630" y="656052"/>
            <a:ext cx="9888569" cy="31945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69411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7AF4FBD0EF6344282D2A6B5A41CE740" ma:contentTypeVersion="13" ma:contentTypeDescription="Create a new document." ma:contentTypeScope="" ma:versionID="f36a42e89863c222e1a86237bff85f95">
  <xsd:schema xmlns:xsd="http://www.w3.org/2001/XMLSchema" xmlns:xs="http://www.w3.org/2001/XMLSchema" xmlns:p="http://schemas.microsoft.com/office/2006/metadata/properties" xmlns:ns3="42a8c8f4-2b3f-487c-a2c0-52867899e17f" xmlns:ns4="f277241c-0a06-40ed-80e7-db15976b983c" targetNamespace="http://schemas.microsoft.com/office/2006/metadata/properties" ma:root="true" ma:fieldsID="b3cfc3626e57edfe8449b4680d157e43" ns3:_="" ns4:_="">
    <xsd:import namespace="42a8c8f4-2b3f-487c-a2c0-52867899e17f"/>
    <xsd:import namespace="f277241c-0a06-40ed-80e7-db15976b983c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2a8c8f4-2b3f-487c-a2c0-52867899e17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OCR" ma:index="11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277241c-0a06-40ed-80e7-db15976b983c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3D123BCD-3F69-46F2-9442-C00D752108C6}">
  <ds:schemaRefs>
    <ds:schemaRef ds:uri="42a8c8f4-2b3f-487c-a2c0-52867899e17f"/>
    <ds:schemaRef ds:uri="f277241c-0a06-40ed-80e7-db15976b983c"/>
    <ds:schemaRef ds:uri="http://purl.org/dc/dcmitype/"/>
    <ds:schemaRef ds:uri="http://purl.org/dc/elements/1.1/"/>
    <ds:schemaRef ds:uri="http://purl.org/dc/terms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schemas.openxmlformats.org/package/2006/metadata/core-properties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0A0AD371-6A07-4BE4-BDD5-4B766977AA5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B7BCDF73-AD83-47F0-8251-3E41A2640897}">
  <ds:schemaRefs>
    <ds:schemaRef ds:uri="42a8c8f4-2b3f-487c-a2c0-52867899e17f"/>
    <ds:schemaRef ds:uri="f277241c-0a06-40ed-80e7-db15976b983c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5028</TotalTime>
  <Words>235</Words>
  <Application>Microsoft Office PowerPoint</Application>
  <PresentationFormat>Widescreen</PresentationFormat>
  <Paragraphs>27</Paragraphs>
  <Slides>15</Slides>
  <Notes>1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Bristol-Myers Squibb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ey, Brian</dc:creator>
  <cp:lastModifiedBy>Arey, Brian</cp:lastModifiedBy>
  <cp:revision>4</cp:revision>
  <cp:lastPrinted>2022-08-29T14:07:55Z</cp:lastPrinted>
  <dcterms:created xsi:type="dcterms:W3CDTF">2020-02-12T18:19:46Z</dcterms:created>
  <dcterms:modified xsi:type="dcterms:W3CDTF">2023-05-12T18:59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7AF4FBD0EF6344282D2A6B5A41CE740</vt:lpwstr>
  </property>
</Properties>
</file>